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56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26" d="100"/>
          <a:sy n="126" d="100"/>
        </p:scale>
        <p:origin x="978" y="132"/>
      </p:cViewPr>
      <p:guideLst>
        <p:guide orient="horz" pos="2256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16E46-D862-46BC-90D9-730B4434E019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E61E0-D8E7-4937-AF25-A65EECAFC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5914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16E46-D862-46BC-90D9-730B4434E019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E61E0-D8E7-4937-AF25-A65EECAFC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319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16E46-D862-46BC-90D9-730B4434E019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E61E0-D8E7-4937-AF25-A65EECAFC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935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16E46-D862-46BC-90D9-730B4434E019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E61E0-D8E7-4937-AF25-A65EECAFC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714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16E46-D862-46BC-90D9-730B4434E019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E61E0-D8E7-4937-AF25-A65EECAFC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082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16E46-D862-46BC-90D9-730B4434E019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E61E0-D8E7-4937-AF25-A65EECAFC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165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16E46-D862-46BC-90D9-730B4434E019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E61E0-D8E7-4937-AF25-A65EECAFC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888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16E46-D862-46BC-90D9-730B4434E019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E61E0-D8E7-4937-AF25-A65EECAFC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2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16E46-D862-46BC-90D9-730B4434E019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E61E0-D8E7-4937-AF25-A65EECAFC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710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16E46-D862-46BC-90D9-730B4434E019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E61E0-D8E7-4937-AF25-A65EECAFC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284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516E46-D862-46BC-90D9-730B4434E019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4E61E0-D8E7-4937-AF25-A65EECAFC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966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516E46-D862-46BC-90D9-730B4434E019}" type="datetimeFigureOut">
              <a:rPr lang="en-US" smtClean="0"/>
              <a:t>9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4E61E0-D8E7-4937-AF25-A65EECAFC2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4807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2B8FE4E0-9AA3-49E6-AA33-12C6133423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2490122"/>
              </p:ext>
            </p:extLst>
          </p:nvPr>
        </p:nvGraphicFramePr>
        <p:xfrm>
          <a:off x="2481261" y="604519"/>
          <a:ext cx="3024119" cy="23237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Prism 8" r:id="rId3" imgW="3796191" imgH="2918328" progId="Prism8.Document">
                  <p:embed/>
                </p:oleObj>
              </mc:Choice>
              <mc:Fallback>
                <p:oleObj name="Prism 8" r:id="rId3" imgW="3796191" imgH="2918328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62FD824A-FEFD-4BAF-B365-587778740E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81261" y="604519"/>
                        <a:ext cx="3024119" cy="23237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71FDBCA2-6AF3-49FF-8337-6814C329C32F}"/>
              </a:ext>
            </a:extLst>
          </p:cNvPr>
          <p:cNvSpPr txBox="1"/>
          <p:nvPr/>
        </p:nvSpPr>
        <p:spPr>
          <a:xfrm>
            <a:off x="2066862" y="242118"/>
            <a:ext cx="42487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cs typeface="Arial" panose="020B0604020202020204" pitchFamily="34" charset="0"/>
              </a:rPr>
              <a:t>A. Age and MN titers against A/New York/108/2016 (H7N2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C61A122-ABDF-4C2D-B0E4-2A2206ED8C7B}"/>
              </a:ext>
            </a:extLst>
          </p:cNvPr>
          <p:cNvSpPr txBox="1"/>
          <p:nvPr/>
        </p:nvSpPr>
        <p:spPr>
          <a:xfrm>
            <a:off x="4572638" y="934113"/>
            <a:ext cx="734592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 i="1" dirty="0">
                <a:cs typeface="Arial" panose="020B0604020202020204" pitchFamily="34" charset="0"/>
              </a:rPr>
              <a:t>r</a:t>
            </a:r>
            <a:r>
              <a:rPr lang="en-US" sz="1000" b="1" dirty="0">
                <a:cs typeface="Arial" panose="020B0604020202020204" pitchFamily="34" charset="0"/>
              </a:rPr>
              <a:t>= - 0.2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D0C3B21-BF52-4AC7-89A5-5665BC6C903F}"/>
              </a:ext>
            </a:extLst>
          </p:cNvPr>
          <p:cNvSpPr txBox="1"/>
          <p:nvPr/>
        </p:nvSpPr>
        <p:spPr>
          <a:xfrm>
            <a:off x="2066862" y="2903220"/>
            <a:ext cx="44958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cs typeface="Arial" panose="020B0604020202020204" pitchFamily="34" charset="0"/>
              </a:rPr>
              <a:t>B. Age and MN titers against A/duck/Bangladesh/19097/2013 (H5N1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0ED92AF-11C9-4AD9-8210-479662FC4091}"/>
              </a:ext>
            </a:extLst>
          </p:cNvPr>
          <p:cNvSpPr txBox="1"/>
          <p:nvPr/>
        </p:nvSpPr>
        <p:spPr>
          <a:xfrm>
            <a:off x="4572638" y="3711269"/>
            <a:ext cx="734592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 i="1" dirty="0">
                <a:cs typeface="Arial" panose="020B0604020202020204" pitchFamily="34" charset="0"/>
              </a:rPr>
              <a:t>r</a:t>
            </a:r>
            <a:r>
              <a:rPr lang="en-US" sz="1000" b="1" dirty="0">
                <a:cs typeface="Arial" panose="020B0604020202020204" pitchFamily="34" charset="0"/>
              </a:rPr>
              <a:t>= - 0.31</a:t>
            </a:r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9A4F5DC1-30FA-4C4C-9F75-A81005A226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9539322"/>
              </p:ext>
            </p:extLst>
          </p:nvPr>
        </p:nvGraphicFramePr>
        <p:xfrm>
          <a:off x="2558812" y="3375988"/>
          <a:ext cx="3024119" cy="23237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name="Prism 8" r:id="rId5" imgW="3796191" imgH="2918328" progId="Prism8.Document">
                  <p:embed/>
                </p:oleObj>
              </mc:Choice>
              <mc:Fallback>
                <p:oleObj name="Prism 8" r:id="rId5" imgW="3796191" imgH="2918328" progId="Prism8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2B8FE4E0-9AA3-49E6-AA33-12C6133423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558812" y="3375988"/>
                        <a:ext cx="3024119" cy="23237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89B2F7B7-FB31-49E7-88E1-CD157C7CC7F0}"/>
              </a:ext>
            </a:extLst>
          </p:cNvPr>
          <p:cNvSpPr/>
          <p:nvPr/>
        </p:nvSpPr>
        <p:spPr>
          <a:xfrm>
            <a:off x="2379282" y="5699760"/>
            <a:ext cx="4572000" cy="73866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400" b="1" dirty="0">
                <a:ea typeface="Times New Roman" panose="02020603050405020304" pitchFamily="18" charset="0"/>
              </a:rPr>
              <a:t>FIGURE S3. </a:t>
            </a:r>
            <a:r>
              <a:rPr lang="en-US" sz="1400" dirty="0">
                <a:ea typeface="Times New Roman" panose="02020603050405020304" pitchFamily="18" charset="0"/>
              </a:rPr>
              <a:t>Negative Pearson’s </a:t>
            </a:r>
            <a:r>
              <a:rPr lang="en-US" sz="1400" i="1" dirty="0">
                <a:ea typeface="Times New Roman" panose="02020603050405020304" pitchFamily="18" charset="0"/>
              </a:rPr>
              <a:t>r</a:t>
            </a:r>
            <a:r>
              <a:rPr lang="en-US" sz="1400" dirty="0">
                <a:ea typeface="Times New Roman" panose="02020603050405020304" pitchFamily="18" charset="0"/>
              </a:rPr>
              <a:t> value between ages and MN titers against A/New York/108/2016 and against A/duck/Bangladesh/19097/2013 (H5N1, 2.3.2.1a).</a:t>
            </a:r>
          </a:p>
        </p:txBody>
      </p:sp>
    </p:spTree>
    <p:extLst>
      <p:ext uri="{BB962C8B-B14F-4D97-AF65-F5344CB8AC3E}">
        <p14:creationId xmlns:p14="http://schemas.microsoft.com/office/powerpoint/2010/main" val="1887503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3</TotalTime>
  <Words>74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Zhunan (CDC/DDID/NCIRD/ID)</dc:creator>
  <cp:lastModifiedBy>Li, Zhunan (CDC/DDID/NCIRD/ID)</cp:lastModifiedBy>
  <cp:revision>15</cp:revision>
  <cp:lastPrinted>2019-09-17T17:31:06Z</cp:lastPrinted>
  <dcterms:created xsi:type="dcterms:W3CDTF">2019-09-17T16:59:09Z</dcterms:created>
  <dcterms:modified xsi:type="dcterms:W3CDTF">2019-09-18T15:04:27Z</dcterms:modified>
</cp:coreProperties>
</file>